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2" r:id="rId2"/>
    <p:sldId id="533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49" userDrawn="1">
          <p15:clr>
            <a:srgbClr val="A4A3A4"/>
          </p15:clr>
        </p15:guide>
        <p15:guide id="2" pos="2139" userDrawn="1">
          <p15:clr>
            <a:srgbClr val="A4A3A4"/>
          </p15:clr>
        </p15:guide>
        <p15:guide id="3" orient="horz" pos="11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7" d="100"/>
          <a:sy n="97" d="100"/>
        </p:scale>
        <p:origin x="996" y="72"/>
      </p:cViewPr>
      <p:guideLst>
        <p:guide orient="horz" pos="3249"/>
        <p:guide pos="2139"/>
        <p:guide orient="horz" pos="11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3836C2F-6838-E306-9C37-BD3588DA86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8E3D844-3135-3A4C-0D80-7BD46FE917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1B7F4C-3194-E04B-9D1C-9B69050F8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408098D-AF3C-6EBD-21ED-0780A29C4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F217218-2370-94DB-0974-783B23D956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997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045FC13-5DB8-C482-8E3F-1CA651E4C1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0991D4D-A5AA-BD16-1AFB-5F1FB06C8F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8F727A6-44BE-B2B0-403D-595FAE1BA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FD361EE-C352-D472-CCF9-F531648A2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CD29335-B211-2BEA-3C20-67D9240DF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480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CD7766E-894B-F097-0E76-F6698203C4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87B0A56-60EF-5633-2818-78820B3020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1B1488B-BEB3-3E79-0618-BC1EA85C16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F9E76D-36A9-2BBB-6653-C3D7E36BA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B719974-52B3-2443-266C-0994ABA82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1498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07948BE-9436-DDB2-5252-6ADB9093AD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CD99F33-FCEF-A531-2473-D983603EBE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D9F8D21-081D-7E94-6A3D-07A556F5A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1B36F6-61D2-C53B-556A-DF335D883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54CD04F-C0FC-EA5F-9E29-43175680D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9482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B3F39D-42D7-D209-10AF-3BDD708E8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4D483E9-A803-DD67-9380-277A1E71E0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E76A97-EFFF-8963-6067-0C696DC82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D53036-4848-4A37-9642-77DDC6911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944A212-BD3A-1446-F2F9-F1691CDC4B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5425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F8CA2F-72D9-F213-C862-0EE03711E5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36F1A04-ECD3-EB54-3BF3-A48C643911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D2A10AF-FEDC-F7E7-65E2-67D2012B44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789E755-7685-5E87-A5F4-3AD66531D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26F0F57-7EC6-3CA0-280F-A57AABA58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E27673B-C59F-A295-B840-164011E09C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4982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62B4A8D-E45E-4C30-C8A6-65F85288D1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8669742-6C4C-67F5-3036-4E38FCD6E4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743B696-0347-8C1A-DA3D-AF4E2A5755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549CC7F-AB26-34C0-6E28-C61586F368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60CF600-BB66-E620-958C-531EA1DF35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D041CA7-160F-9E5B-4623-6FB596FCA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F134BCE-388C-6963-B562-3C417EA66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DCC16EF-5136-F21F-585B-9D28959C5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7719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B2B3A28-2CBA-C266-8FAA-00C27F4952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989B7E5-2611-CE05-7E70-8F7696E68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ECEBD87-E94D-F956-260A-12F28DE23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8DABDA3-CFC0-CA23-C994-5EC439B00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4748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363F1E2-712A-A6B3-E44A-A705E4C24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188EBB6-3C2D-CECF-B3AA-E5E6ED80C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DC88409-0B27-D15C-E911-D429E1CFD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2585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11A611E-2EF0-65B2-2D7C-DD4B74CD9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76C45B3-5096-14D6-88E9-9C15876CC4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DA139C2-06FE-09D0-74F8-CB5D35A3CE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338F6D5-2894-4ED6-B387-7029C1A5A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25A6F67-FEF4-8623-812C-064EABC98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1BC86F7-0992-A06B-CAD4-5FF8E248A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1772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8D1BDC9-9EFE-C507-DF48-0B75B8923B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3A1ECB8-0816-9799-E8EA-A5714FB11A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DEE46E2-8ABF-F521-1DB6-B53A6385D2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0B137D7-8E7C-4048-D393-739B98AE1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D86FD15-5161-F902-C557-70C88493D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833FF3F-B51B-3F4C-3C4D-F50CABA04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6878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AE64C70-DE98-B6EB-E987-93B19E0BA7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BE9AFC-6781-DA5C-2F5D-98997A62FD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8D7B1AB-30AE-A30F-6787-700E1516D9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2F543-459D-459D-A3B1-CD49F0A5EDD2}" type="datetimeFigureOut">
              <a:rPr lang="it-IT" smtClean="0"/>
              <a:t>24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AD5E7F6-9D25-FCAA-D246-42789FE2BF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86B3A0B-1FA7-B164-9DF4-9B5DF4C98C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663CD7-C833-49AD-9B9C-38D2691F41C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7314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C738A98-02D1-F10E-78D9-0C13C9CCDA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3132757" y="1251065"/>
            <a:ext cx="3205779" cy="45415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85F3064-CC6E-16D6-68B1-C950DA7A54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6585309" y="1241367"/>
            <a:ext cx="3205779" cy="4541520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CF26495A-8B9E-96AF-0880-657897F53A6F}"/>
              </a:ext>
            </a:extLst>
          </p:cNvPr>
          <p:cNvSpPr txBox="1"/>
          <p:nvPr/>
        </p:nvSpPr>
        <p:spPr>
          <a:xfrm>
            <a:off x="3078783" y="1136400"/>
            <a:ext cx="15165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C. paradoxa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90-28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10">
            <a:extLst>
              <a:ext uri="{FF2B5EF4-FFF2-40B4-BE49-F238E27FC236}">
                <a16:creationId xmlns:a16="http://schemas.microsoft.com/office/drawing/2014/main" id="{B3AF8B27-F645-53FD-005A-BC4ECB07447E}"/>
              </a:ext>
            </a:extLst>
          </p:cNvPr>
          <p:cNvSpPr txBox="1"/>
          <p:nvPr/>
        </p:nvSpPr>
        <p:spPr>
          <a:xfrm>
            <a:off x="3344746" y="1490432"/>
            <a:ext cx="874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" name="CasellaDiTesto 13">
            <a:extLst>
              <a:ext uri="{FF2B5EF4-FFF2-40B4-BE49-F238E27FC236}">
                <a16:creationId xmlns:a16="http://schemas.microsoft.com/office/drawing/2014/main" id="{40329540-C53C-3A08-C7C2-FD9262A04811}"/>
              </a:ext>
            </a:extLst>
          </p:cNvPr>
          <p:cNvSpPr txBox="1"/>
          <p:nvPr/>
        </p:nvSpPr>
        <p:spPr>
          <a:xfrm>
            <a:off x="5083565" y="149043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0" name="CasellaDiTesto 15">
            <a:extLst>
              <a:ext uri="{FF2B5EF4-FFF2-40B4-BE49-F238E27FC236}">
                <a16:creationId xmlns:a16="http://schemas.microsoft.com/office/drawing/2014/main" id="{BD6151B0-AC0B-AC22-9C06-71634A44F1B1}"/>
              </a:ext>
            </a:extLst>
          </p:cNvPr>
          <p:cNvSpPr txBox="1"/>
          <p:nvPr/>
        </p:nvSpPr>
        <p:spPr>
          <a:xfrm>
            <a:off x="3850255" y="149043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11" name="CasellaDiTesto 16">
            <a:extLst>
              <a:ext uri="{FF2B5EF4-FFF2-40B4-BE49-F238E27FC236}">
                <a16:creationId xmlns:a16="http://schemas.microsoft.com/office/drawing/2014/main" id="{672D868C-7610-F86B-6238-2251312AF756}"/>
              </a:ext>
            </a:extLst>
          </p:cNvPr>
          <p:cNvSpPr txBox="1"/>
          <p:nvPr/>
        </p:nvSpPr>
        <p:spPr>
          <a:xfrm>
            <a:off x="5597984" y="149043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13" name="CasellaDiTesto 18">
            <a:extLst>
              <a:ext uri="{FF2B5EF4-FFF2-40B4-BE49-F238E27FC236}">
                <a16:creationId xmlns:a16="http://schemas.microsoft.com/office/drawing/2014/main" id="{4C0A5EE9-A072-2E56-206A-3CB5BC967A80}"/>
              </a:ext>
            </a:extLst>
          </p:cNvPr>
          <p:cNvSpPr txBox="1"/>
          <p:nvPr/>
        </p:nvSpPr>
        <p:spPr>
          <a:xfrm>
            <a:off x="4174819" y="1136400"/>
            <a:ext cx="108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S. lycopersicum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43-225</a:t>
            </a:r>
          </a:p>
        </p:txBody>
      </p:sp>
      <p:sp>
        <p:nvSpPr>
          <p:cNvPr id="14" name="CasellaDiTesto 19">
            <a:extLst>
              <a:ext uri="{FF2B5EF4-FFF2-40B4-BE49-F238E27FC236}">
                <a16:creationId xmlns:a16="http://schemas.microsoft.com/office/drawing/2014/main" id="{5F27AB14-4C47-EDB9-C039-FA4FFDC5DE47}"/>
              </a:ext>
            </a:extLst>
          </p:cNvPr>
          <p:cNvSpPr txBox="1"/>
          <p:nvPr/>
        </p:nvSpPr>
        <p:spPr>
          <a:xfrm>
            <a:off x="5138455" y="1136400"/>
            <a:ext cx="93647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O. sativa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34-216</a:t>
            </a:r>
          </a:p>
        </p:txBody>
      </p:sp>
      <p:sp>
        <p:nvSpPr>
          <p:cNvPr id="16" name="CasellaDiTesto 10">
            <a:extLst>
              <a:ext uri="{FF2B5EF4-FFF2-40B4-BE49-F238E27FC236}">
                <a16:creationId xmlns:a16="http://schemas.microsoft.com/office/drawing/2014/main" id="{AF337D91-F50E-5065-4001-06F09ED4FF9A}"/>
              </a:ext>
            </a:extLst>
          </p:cNvPr>
          <p:cNvSpPr txBox="1"/>
          <p:nvPr/>
        </p:nvSpPr>
        <p:spPr>
          <a:xfrm>
            <a:off x="4228547" y="1490432"/>
            <a:ext cx="874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7" name="CasellaDiTesto 15">
            <a:extLst>
              <a:ext uri="{FF2B5EF4-FFF2-40B4-BE49-F238E27FC236}">
                <a16:creationId xmlns:a16="http://schemas.microsoft.com/office/drawing/2014/main" id="{AD72CEC0-36BB-C96C-5F94-E03511610844}"/>
              </a:ext>
            </a:extLst>
          </p:cNvPr>
          <p:cNvSpPr txBox="1"/>
          <p:nvPr/>
        </p:nvSpPr>
        <p:spPr>
          <a:xfrm>
            <a:off x="4695807" y="149043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18" name="CasellaDiTesto 5">
            <a:extLst>
              <a:ext uri="{FF2B5EF4-FFF2-40B4-BE49-F238E27FC236}">
                <a16:creationId xmlns:a16="http://schemas.microsoft.com/office/drawing/2014/main" id="{91EC16BC-AC07-1107-AB46-726637EFEE3B}"/>
              </a:ext>
            </a:extLst>
          </p:cNvPr>
          <p:cNvSpPr txBox="1"/>
          <p:nvPr/>
        </p:nvSpPr>
        <p:spPr>
          <a:xfrm>
            <a:off x="6604146" y="1136400"/>
            <a:ext cx="15165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C. paradoxa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90-28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asellaDiTesto 10">
            <a:extLst>
              <a:ext uri="{FF2B5EF4-FFF2-40B4-BE49-F238E27FC236}">
                <a16:creationId xmlns:a16="http://schemas.microsoft.com/office/drawing/2014/main" id="{B9B9B972-C953-CE8A-EEBF-9550E89352F1}"/>
              </a:ext>
            </a:extLst>
          </p:cNvPr>
          <p:cNvSpPr txBox="1"/>
          <p:nvPr/>
        </p:nvSpPr>
        <p:spPr>
          <a:xfrm>
            <a:off x="6870109" y="1490432"/>
            <a:ext cx="874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20" name="CasellaDiTesto 13">
            <a:extLst>
              <a:ext uri="{FF2B5EF4-FFF2-40B4-BE49-F238E27FC236}">
                <a16:creationId xmlns:a16="http://schemas.microsoft.com/office/drawing/2014/main" id="{8601BF9C-F754-9A82-160C-ADADD5C38FF2}"/>
              </a:ext>
            </a:extLst>
          </p:cNvPr>
          <p:cNvSpPr txBox="1"/>
          <p:nvPr/>
        </p:nvSpPr>
        <p:spPr>
          <a:xfrm>
            <a:off x="8608928" y="149043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21" name="CasellaDiTesto 15">
            <a:extLst>
              <a:ext uri="{FF2B5EF4-FFF2-40B4-BE49-F238E27FC236}">
                <a16:creationId xmlns:a16="http://schemas.microsoft.com/office/drawing/2014/main" id="{09E62C1D-F54B-2C1B-4505-FCA642872ACB}"/>
              </a:ext>
            </a:extLst>
          </p:cNvPr>
          <p:cNvSpPr txBox="1"/>
          <p:nvPr/>
        </p:nvSpPr>
        <p:spPr>
          <a:xfrm>
            <a:off x="7375618" y="149043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22" name="CasellaDiTesto 16">
            <a:extLst>
              <a:ext uri="{FF2B5EF4-FFF2-40B4-BE49-F238E27FC236}">
                <a16:creationId xmlns:a16="http://schemas.microsoft.com/office/drawing/2014/main" id="{2B584E1B-C677-1C4E-88DF-A9E8802ABF81}"/>
              </a:ext>
            </a:extLst>
          </p:cNvPr>
          <p:cNvSpPr txBox="1"/>
          <p:nvPr/>
        </p:nvSpPr>
        <p:spPr>
          <a:xfrm>
            <a:off x="9123347" y="149043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23" name="CasellaDiTesto 18">
            <a:extLst>
              <a:ext uri="{FF2B5EF4-FFF2-40B4-BE49-F238E27FC236}">
                <a16:creationId xmlns:a16="http://schemas.microsoft.com/office/drawing/2014/main" id="{577EB6CC-53F9-57A5-3C5A-4F34FDAA89F3}"/>
              </a:ext>
            </a:extLst>
          </p:cNvPr>
          <p:cNvSpPr txBox="1"/>
          <p:nvPr/>
        </p:nvSpPr>
        <p:spPr>
          <a:xfrm>
            <a:off x="7700182" y="1136400"/>
            <a:ext cx="108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S. lycopersicum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43-225</a:t>
            </a:r>
          </a:p>
        </p:txBody>
      </p:sp>
      <p:sp>
        <p:nvSpPr>
          <p:cNvPr id="24" name="CasellaDiTesto 19">
            <a:extLst>
              <a:ext uri="{FF2B5EF4-FFF2-40B4-BE49-F238E27FC236}">
                <a16:creationId xmlns:a16="http://schemas.microsoft.com/office/drawing/2014/main" id="{4F79D9C1-D8A8-9F7B-E507-056E5444F50F}"/>
              </a:ext>
            </a:extLst>
          </p:cNvPr>
          <p:cNvSpPr txBox="1"/>
          <p:nvPr/>
        </p:nvSpPr>
        <p:spPr>
          <a:xfrm>
            <a:off x="8663818" y="1136400"/>
            <a:ext cx="93647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O. sativa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34-216</a:t>
            </a:r>
          </a:p>
        </p:txBody>
      </p:sp>
      <p:sp>
        <p:nvSpPr>
          <p:cNvPr id="25" name="CasellaDiTesto 10">
            <a:extLst>
              <a:ext uri="{FF2B5EF4-FFF2-40B4-BE49-F238E27FC236}">
                <a16:creationId xmlns:a16="http://schemas.microsoft.com/office/drawing/2014/main" id="{C11E1F22-3254-974A-6BF5-1CDA0630A83D}"/>
              </a:ext>
            </a:extLst>
          </p:cNvPr>
          <p:cNvSpPr txBox="1"/>
          <p:nvPr/>
        </p:nvSpPr>
        <p:spPr>
          <a:xfrm>
            <a:off x="7753910" y="1490432"/>
            <a:ext cx="874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26" name="CasellaDiTesto 15">
            <a:extLst>
              <a:ext uri="{FF2B5EF4-FFF2-40B4-BE49-F238E27FC236}">
                <a16:creationId xmlns:a16="http://schemas.microsoft.com/office/drawing/2014/main" id="{7C40ADA9-80D0-E117-EC20-A38068B4001E}"/>
              </a:ext>
            </a:extLst>
          </p:cNvPr>
          <p:cNvSpPr txBox="1"/>
          <p:nvPr/>
        </p:nvSpPr>
        <p:spPr>
          <a:xfrm>
            <a:off x="8221170" y="149043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F2DEE6E-CC45-D9B2-AC68-97E6F1F94D7C}"/>
              </a:ext>
            </a:extLst>
          </p:cNvPr>
          <p:cNvSpPr/>
          <p:nvPr/>
        </p:nvSpPr>
        <p:spPr>
          <a:xfrm>
            <a:off x="3390687" y="2572380"/>
            <a:ext cx="910008" cy="12610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BCAD5C1-F8D3-2820-51E8-CE04DC4C0604}"/>
              </a:ext>
            </a:extLst>
          </p:cNvPr>
          <p:cNvSpPr/>
          <p:nvPr/>
        </p:nvSpPr>
        <p:spPr>
          <a:xfrm>
            <a:off x="5204366" y="2572379"/>
            <a:ext cx="1025612" cy="12610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09BBB2F-25E6-B6EE-7542-E4FAFCEEFCC3}"/>
              </a:ext>
            </a:extLst>
          </p:cNvPr>
          <p:cNvSpPr/>
          <p:nvPr/>
        </p:nvSpPr>
        <p:spPr>
          <a:xfrm>
            <a:off x="7753910" y="2572379"/>
            <a:ext cx="947094" cy="12610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CasellaDiTesto 7">
            <a:extLst>
              <a:ext uri="{FF2B5EF4-FFF2-40B4-BE49-F238E27FC236}">
                <a16:creationId xmlns:a16="http://schemas.microsoft.com/office/drawing/2014/main" id="{E4EF94C9-B5D3-1C35-DEE2-53F00230168A}"/>
              </a:ext>
            </a:extLst>
          </p:cNvPr>
          <p:cNvSpPr txBox="1"/>
          <p:nvPr/>
        </p:nvSpPr>
        <p:spPr>
          <a:xfrm>
            <a:off x="328670" y="309366"/>
            <a:ext cx="1466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ho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-tag Anti-GFP</a:t>
            </a:r>
          </a:p>
        </p:txBody>
      </p:sp>
    </p:spTree>
    <p:extLst>
      <p:ext uri="{BB962C8B-B14F-4D97-AF65-F5344CB8AC3E}">
        <p14:creationId xmlns:p14="http://schemas.microsoft.com/office/powerpoint/2010/main" val="5118411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CFF548A-4BF6-C8B7-F0A1-E85A23B3FF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5663" y="1777254"/>
            <a:ext cx="4396834" cy="3380534"/>
          </a:xfrm>
          <a:prstGeom prst="rect">
            <a:avLst/>
          </a:prstGeom>
        </p:spPr>
      </p:pic>
      <p:sp>
        <p:nvSpPr>
          <p:cNvPr id="4" name="CasellaDiTesto 5">
            <a:extLst>
              <a:ext uri="{FF2B5EF4-FFF2-40B4-BE49-F238E27FC236}">
                <a16:creationId xmlns:a16="http://schemas.microsoft.com/office/drawing/2014/main" id="{91351103-F616-A4A3-1E70-E88C781AC354}"/>
              </a:ext>
            </a:extLst>
          </p:cNvPr>
          <p:cNvSpPr txBox="1"/>
          <p:nvPr/>
        </p:nvSpPr>
        <p:spPr>
          <a:xfrm>
            <a:off x="3721877" y="1142207"/>
            <a:ext cx="15165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C. paradoxa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90-28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10">
            <a:extLst>
              <a:ext uri="{FF2B5EF4-FFF2-40B4-BE49-F238E27FC236}">
                <a16:creationId xmlns:a16="http://schemas.microsoft.com/office/drawing/2014/main" id="{11EE4E5F-86B4-596C-D73B-CFF67D48E17B}"/>
              </a:ext>
            </a:extLst>
          </p:cNvPr>
          <p:cNvSpPr txBox="1"/>
          <p:nvPr/>
        </p:nvSpPr>
        <p:spPr>
          <a:xfrm>
            <a:off x="3987840" y="1496239"/>
            <a:ext cx="874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6" name="CasellaDiTesto 15">
            <a:extLst>
              <a:ext uri="{FF2B5EF4-FFF2-40B4-BE49-F238E27FC236}">
                <a16:creationId xmlns:a16="http://schemas.microsoft.com/office/drawing/2014/main" id="{18829ADA-2BA1-CB95-D3C6-7912F570FBDB}"/>
              </a:ext>
            </a:extLst>
          </p:cNvPr>
          <p:cNvSpPr txBox="1"/>
          <p:nvPr/>
        </p:nvSpPr>
        <p:spPr>
          <a:xfrm>
            <a:off x="4493349" y="1496239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7" name="CasellaDiTesto 13">
            <a:extLst>
              <a:ext uri="{FF2B5EF4-FFF2-40B4-BE49-F238E27FC236}">
                <a16:creationId xmlns:a16="http://schemas.microsoft.com/office/drawing/2014/main" id="{4C8FED8E-6C77-858A-328E-ADB6147F7C0E}"/>
              </a:ext>
            </a:extLst>
          </p:cNvPr>
          <p:cNvSpPr txBox="1"/>
          <p:nvPr/>
        </p:nvSpPr>
        <p:spPr>
          <a:xfrm>
            <a:off x="6598912" y="149623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" name="CasellaDiTesto 16">
            <a:extLst>
              <a:ext uri="{FF2B5EF4-FFF2-40B4-BE49-F238E27FC236}">
                <a16:creationId xmlns:a16="http://schemas.microsoft.com/office/drawing/2014/main" id="{D249AA75-E857-AEA8-42AE-9F5C78D76D12}"/>
              </a:ext>
            </a:extLst>
          </p:cNvPr>
          <p:cNvSpPr txBox="1"/>
          <p:nvPr/>
        </p:nvSpPr>
        <p:spPr>
          <a:xfrm>
            <a:off x="7113331" y="1496239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9" name="CasellaDiTesto 18">
            <a:extLst>
              <a:ext uri="{FF2B5EF4-FFF2-40B4-BE49-F238E27FC236}">
                <a16:creationId xmlns:a16="http://schemas.microsoft.com/office/drawing/2014/main" id="{94193F8F-63C2-3161-E717-38BFA2409644}"/>
              </a:ext>
            </a:extLst>
          </p:cNvPr>
          <p:cNvSpPr txBox="1"/>
          <p:nvPr/>
        </p:nvSpPr>
        <p:spPr>
          <a:xfrm>
            <a:off x="5690166" y="1142207"/>
            <a:ext cx="108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S. lycopersicum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43-225</a:t>
            </a:r>
          </a:p>
        </p:txBody>
      </p:sp>
      <p:sp>
        <p:nvSpPr>
          <p:cNvPr id="10" name="CasellaDiTesto 19">
            <a:extLst>
              <a:ext uri="{FF2B5EF4-FFF2-40B4-BE49-F238E27FC236}">
                <a16:creationId xmlns:a16="http://schemas.microsoft.com/office/drawing/2014/main" id="{B3BFC433-4DD9-F8A1-953A-80D604EE3385}"/>
              </a:ext>
            </a:extLst>
          </p:cNvPr>
          <p:cNvSpPr txBox="1"/>
          <p:nvPr/>
        </p:nvSpPr>
        <p:spPr>
          <a:xfrm>
            <a:off x="6653802" y="1142207"/>
            <a:ext cx="93647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O. sativa</a:t>
            </a:r>
          </a:p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SH2/3</a:t>
            </a:r>
            <a:r>
              <a:rPr lang="it-IT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34-216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69BACAF-19BE-F8FB-9F96-CC73E4586E9E}"/>
              </a:ext>
            </a:extLst>
          </p:cNvPr>
          <p:cNvSpPr txBox="1"/>
          <p:nvPr/>
        </p:nvSpPr>
        <p:spPr>
          <a:xfrm>
            <a:off x="5743894" y="1496239"/>
            <a:ext cx="874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2" name="CasellaDiTesto 15">
            <a:extLst>
              <a:ext uri="{FF2B5EF4-FFF2-40B4-BE49-F238E27FC236}">
                <a16:creationId xmlns:a16="http://schemas.microsoft.com/office/drawing/2014/main" id="{6184011F-C091-0FC0-D3B4-AE1D91787776}"/>
              </a:ext>
            </a:extLst>
          </p:cNvPr>
          <p:cNvSpPr txBox="1"/>
          <p:nvPr/>
        </p:nvSpPr>
        <p:spPr>
          <a:xfrm>
            <a:off x="6211154" y="1496239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13" name="CasellaDiTesto 7">
            <a:extLst>
              <a:ext uri="{FF2B5EF4-FFF2-40B4-BE49-F238E27FC236}">
                <a16:creationId xmlns:a16="http://schemas.microsoft.com/office/drawing/2014/main" id="{89117AB8-7BC1-33C0-6F15-F66B43D35756}"/>
              </a:ext>
            </a:extLst>
          </p:cNvPr>
          <p:cNvSpPr txBox="1"/>
          <p:nvPr/>
        </p:nvSpPr>
        <p:spPr>
          <a:xfrm>
            <a:off x="328670" y="309366"/>
            <a:ext cx="1168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DS Anti-GFP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C51137E-AF0F-1698-628A-6E223D795584}"/>
              </a:ext>
            </a:extLst>
          </p:cNvPr>
          <p:cNvSpPr/>
          <p:nvPr/>
        </p:nvSpPr>
        <p:spPr>
          <a:xfrm>
            <a:off x="3970232" y="3103322"/>
            <a:ext cx="910008" cy="7804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987E82F-2755-72AC-5E27-8CD081C9B23C}"/>
              </a:ext>
            </a:extLst>
          </p:cNvPr>
          <p:cNvSpPr/>
          <p:nvPr/>
        </p:nvSpPr>
        <p:spPr>
          <a:xfrm>
            <a:off x="5743894" y="3395209"/>
            <a:ext cx="910008" cy="606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89DF464-1E63-39A4-FC91-239CD7ADC216}"/>
              </a:ext>
            </a:extLst>
          </p:cNvPr>
          <p:cNvSpPr/>
          <p:nvPr/>
        </p:nvSpPr>
        <p:spPr>
          <a:xfrm>
            <a:off x="6635290" y="3395209"/>
            <a:ext cx="910008" cy="606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0110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Widescreen</PresentationFormat>
  <Paragraphs>3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</dc:creator>
  <cp:lastModifiedBy>FIELD Benjamin</cp:lastModifiedBy>
  <cp:revision>5</cp:revision>
  <dcterms:created xsi:type="dcterms:W3CDTF">2023-03-27T11:08:39Z</dcterms:created>
  <dcterms:modified xsi:type="dcterms:W3CDTF">2023-04-24T11:27:17Z</dcterms:modified>
</cp:coreProperties>
</file>